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2208" y="12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6088C-BDBA-4016-9B2C-F9F83A2E7B05}" type="datetimeFigureOut">
              <a:rPr lang="fr-FR" smtClean="0"/>
              <a:t>14/06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D5CEB5-BDDF-43AD-99FF-F5989198C7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18699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6088C-BDBA-4016-9B2C-F9F83A2E7B05}" type="datetimeFigureOut">
              <a:rPr lang="fr-FR" smtClean="0"/>
              <a:t>14/06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D5CEB5-BDDF-43AD-99FF-F5989198C7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6895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6088C-BDBA-4016-9B2C-F9F83A2E7B05}" type="datetimeFigureOut">
              <a:rPr lang="fr-FR" smtClean="0"/>
              <a:t>14/06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D5CEB5-BDDF-43AD-99FF-F5989198C7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898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6088C-BDBA-4016-9B2C-F9F83A2E7B05}" type="datetimeFigureOut">
              <a:rPr lang="fr-FR" smtClean="0"/>
              <a:t>14/06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D5CEB5-BDDF-43AD-99FF-F5989198C7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93700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6088C-BDBA-4016-9B2C-F9F83A2E7B05}" type="datetimeFigureOut">
              <a:rPr lang="fr-FR" smtClean="0"/>
              <a:t>14/06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D5CEB5-BDDF-43AD-99FF-F5989198C7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2992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6088C-BDBA-4016-9B2C-F9F83A2E7B05}" type="datetimeFigureOut">
              <a:rPr lang="fr-FR" smtClean="0"/>
              <a:t>14/06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D5CEB5-BDDF-43AD-99FF-F5989198C7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9858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6088C-BDBA-4016-9B2C-F9F83A2E7B05}" type="datetimeFigureOut">
              <a:rPr lang="fr-FR" smtClean="0"/>
              <a:t>14/06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D5CEB5-BDDF-43AD-99FF-F5989198C7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262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6088C-BDBA-4016-9B2C-F9F83A2E7B05}" type="datetimeFigureOut">
              <a:rPr lang="fr-FR" smtClean="0"/>
              <a:t>14/06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D5CEB5-BDDF-43AD-99FF-F5989198C7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88386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6088C-BDBA-4016-9B2C-F9F83A2E7B05}" type="datetimeFigureOut">
              <a:rPr lang="fr-FR" smtClean="0"/>
              <a:t>14/06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D5CEB5-BDDF-43AD-99FF-F5989198C7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3423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6088C-BDBA-4016-9B2C-F9F83A2E7B05}" type="datetimeFigureOut">
              <a:rPr lang="fr-FR" smtClean="0"/>
              <a:t>14/06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D5CEB5-BDDF-43AD-99FF-F5989198C7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6065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6088C-BDBA-4016-9B2C-F9F83A2E7B05}" type="datetimeFigureOut">
              <a:rPr lang="fr-FR" smtClean="0"/>
              <a:t>14/06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D5CEB5-BDDF-43AD-99FF-F5989198C7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1322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C6088C-BDBA-4016-9B2C-F9F83A2E7B05}" type="datetimeFigureOut">
              <a:rPr lang="fr-FR" smtClean="0"/>
              <a:t>14/06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D5CEB5-BDDF-43AD-99FF-F5989198C77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85266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476672" y="7452320"/>
            <a:ext cx="5904656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hylogeny of the AA3 predicted proteins from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olyporus brumali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nd biochemically characterized fungal AA3s. Sequence descriptions include accession numbers from JGI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ycocos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NBCI or PDB. The tree was constructed with a strategy similar to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ütz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t al.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ütz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t al.,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Biotechno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Biofuels, 2018). Sequences were aligned using M-coffee (Wallace et al., Nucleic Acids Res. 2006) with default settings. Phylogeny was inferred using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PhyM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Guindo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t al., Syst. Biol. 2010) and WAG amino acid substitution model (Whelan and Goldman, Mol. Biol.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Evo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2001). Branch support was calculated by 500 bootstrap repetitions. The tree was visualized in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TO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Letuni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Bork, Nucleic Acids Res. 2016).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C20195C0-847B-49D7-B1CD-1617C076DB7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8760" y="539552"/>
            <a:ext cx="3770752" cy="6588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480336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136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enoelle</dc:creator>
  <cp:lastModifiedBy>ROSSO Marie noelle</cp:lastModifiedBy>
  <cp:revision>11</cp:revision>
  <dcterms:created xsi:type="dcterms:W3CDTF">2017-12-08T15:19:23Z</dcterms:created>
  <dcterms:modified xsi:type="dcterms:W3CDTF">2018-06-14T09:38:46Z</dcterms:modified>
</cp:coreProperties>
</file>